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06"/>
    <p:restoredTop sz="94703"/>
  </p:normalViewPr>
  <p:slideViewPr>
    <p:cSldViewPr snapToGrid="0">
      <p:cViewPr>
        <p:scale>
          <a:sx n="86" d="100"/>
          <a:sy n="86" d="100"/>
        </p:scale>
        <p:origin x="1592" y="8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702BD5-2A31-9447-AD7B-9A0F15BF5D7B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A7B371-B300-1A40-89C7-D1301BBF90F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38467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zh-CN" sz="1800" dirty="0">
                <a:effectLst/>
                <a:ea typeface="Times New Roman" panose="02020603050405020304" pitchFamily="18" charset="0"/>
              </a:rPr>
              <a:t>*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: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P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&lt; 0.05;</a:t>
            </a:r>
            <a:r>
              <a:rPr lang="zh-CN" altLang="zh-CN" sz="1800" dirty="0">
                <a:effectLst/>
                <a:ea typeface="Times New Roman" panose="02020603050405020304" pitchFamily="18" charset="0"/>
              </a:rPr>
              <a:t> **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: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P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&lt; 0.01;</a:t>
            </a:r>
            <a:r>
              <a:rPr lang="zh-CN" altLang="zh-CN" sz="1800" dirty="0">
                <a:effectLst/>
                <a:ea typeface="Times New Roman" panose="02020603050405020304" pitchFamily="18" charset="0"/>
              </a:rPr>
              <a:t> ***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: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P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 &lt; 0.001; NS : not significant.</a:t>
            </a:r>
            <a:r>
              <a:rPr lang="zh-CN" altLang="zh-CN" dirty="0">
                <a:effectLst/>
              </a:rPr>
              <a:t> </a:t>
            </a:r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A7B371-B300-1A40-89C7-D1301BBF90F1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845512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dirty="0">
                <a:effectLst/>
                <a:latin typeface="Times" pitchFamily="2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s: CPG, cancer predisposition gene.</a:t>
            </a:r>
            <a:endParaRPr lang="zh-CN" altLang="zh-CN" sz="1800" dirty="0">
              <a:effectLst/>
              <a:latin typeface="Times" pitchFamily="2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kumimoji="1" lang="zh-CN" altLang="en-US" dirty="0">
              <a:latin typeface="Times" pitchFamily="2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A7B371-B300-1A40-89C7-D1301BBF90F1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8427206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dirty="0">
                <a:effectLst/>
                <a:latin typeface="Times" pitchFamily="2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s: CPG, cancer predisposition gene.</a:t>
            </a:r>
            <a:endParaRPr lang="zh-CN" altLang="zh-CN" sz="1800" dirty="0">
              <a:effectLst/>
              <a:latin typeface="Times" pitchFamily="2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kumimoji="1" lang="zh-CN" altLang="en-US" dirty="0">
              <a:latin typeface="Times" pitchFamily="2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A7B371-B300-1A40-89C7-D1301BBF90F1}" type="slidenum">
              <a:rPr kumimoji="1" lang="zh-CN" altLang="en-US" smtClean="0"/>
              <a:t>3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9894530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dirty="0">
                <a:effectLst/>
                <a:latin typeface="Times" pitchFamily="2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s: CPG, cancer predisposition gene.</a:t>
            </a:r>
            <a:endParaRPr lang="zh-CN" altLang="zh-CN" sz="1800" dirty="0">
              <a:effectLst/>
              <a:latin typeface="Times" pitchFamily="2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kumimoji="1" lang="zh-CN" altLang="en-US" dirty="0">
              <a:latin typeface="Times" pitchFamily="2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A7B371-B300-1A40-89C7-D1301BBF90F1}" type="slidenum">
              <a:rPr kumimoji="1" lang="zh-CN" altLang="en-US" smtClean="0"/>
              <a:t>4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4134856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dirty="0">
                <a:effectLst/>
                <a:latin typeface="Times" pitchFamily="2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s: CPG, cancer predisposition gene.</a:t>
            </a:r>
            <a:endParaRPr lang="zh-CN" altLang="zh-CN" sz="1800" dirty="0">
              <a:effectLst/>
              <a:latin typeface="Times" pitchFamily="2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endParaRPr kumimoji="1" lang="zh-CN" altLang="en-US" dirty="0">
              <a:latin typeface="Times" pitchFamily="2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FA7B371-B300-1A40-89C7-D1301BBF90F1}" type="slidenum">
              <a:rPr kumimoji="1" lang="zh-CN" altLang="en-US" smtClean="0"/>
              <a:t>5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674240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CFF3F5-C92F-84B5-D645-C576140C41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C985A40-F60F-D357-3453-CBD71C07AD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60365C1-F2D9-B947-7F61-DF25F320F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2FAAB1-6C71-BB1D-C208-CDC84E340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02A4AE-6F2B-403B-7D46-85083A616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1459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88E73E-737B-EBF3-CC71-DE60C51462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14ED404-DC07-6A14-D0F7-679C8F6CE9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BBC222-E7DB-DB84-BEB1-F5225C9D2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BF0466-041C-3A72-FC96-9EA6E45A8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53814F-A53B-0EA1-3076-7425E4E65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68692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C771940-37E4-1222-25F2-493C56A597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CAE59A5-CDBF-B279-3389-9B18836AE1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62024F-E998-6595-B352-30A9555A9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6888BF-CB52-07A0-8CB2-8643BF89F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E362D0-81B5-9422-7CDB-897BC4526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56082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ED9284-6F2D-585C-9521-99AF0F015B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A6357AD-3749-9431-85EA-E3C56B0386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5E6ADD-94A4-938F-E382-203E60B3D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07A527-D4E7-59BF-5A8F-3D8A192DBF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971B09-5B32-EE03-47FB-3938601D6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85792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FA46C4-9BA8-C7B9-0F1D-81BD4585C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1CE7A4-C0CB-0904-AE23-5A1782CCE5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22E80D-5139-3768-AC22-F8DEA439A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DF0961-1AFC-B03E-DB3B-751289290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E469C6-CD4F-40F8-E6B3-7C2BBB25F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08605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5ED2A2-EB3E-746E-23E7-5118BC9546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89A3A01-2A06-2164-2705-DA3BBDBF7D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DE447B-9923-CB8D-8D2A-4184849C3D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BD2A88A-EFE6-0853-37EF-8D80792D8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BB01332-EF8F-887F-04C4-837B545D2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8A06D69-5F72-0AC2-E168-4BDF96A75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93007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6557D8-5089-1999-A109-BC2814DC76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9F0D59C-EBAF-C456-3776-CC922C8996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0BB01AF-87D3-6194-9C74-85F7208897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2DEED52-93B8-0091-D323-BA19B324D3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07E484E-1B79-683D-35AD-AFDF75633B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5F30764-CA73-15CA-61F4-4F0F3D09A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BD9E6DE-9E28-CB2C-8FEC-6E8837E2D1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8DD3D55-CD50-CDFE-BB8F-54B8B2540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51821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CE2689-465E-FF18-C852-4538AB655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E75F6C8-B627-A5FB-0B7C-4214A53C1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38B8DCA-9E69-DF6C-E232-F1C0CAD72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4B46DF0-5EAA-DFC8-5B60-A941216E5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00384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B5F71F-0FBA-4264-A78D-6BF725FD7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CD03B92-62AD-968E-2203-7B2B91B66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945EF6D-FE89-CCA3-D936-3E99708EC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32299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0D903C-FB2C-9541-9CF8-5603FF39B2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99DFB6C-34AA-2B28-FC38-2C164CCE7E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BA75D59-39A5-878D-51C5-548315B81D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ABF8742-092B-A587-E6B6-353BFC459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4E51A15-66FD-5AB7-9CB2-7245C1202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2367CC8-87EB-725F-250E-19EE530AE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93250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8F386A-A8F2-A4DA-3397-F5F3CCBF13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1E5DEFA-634D-E6C4-35F0-0063D960CA3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B41E89F-90B0-00A0-2732-305CD45787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50385F3-8E7C-3198-1B0A-FE91FE38BF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3663B4-28CE-6E33-D3D2-224E81A06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A25A757-D684-0E3B-E655-4BE435973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7249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338F5DE-D85D-AD7D-9892-AD9FE1B9E5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4F79237-3A63-B9E3-F575-CC0AFEE380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A0A359-D9C7-AF3C-0DBA-C88D306B27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B2672-892B-1C42-A51C-6C497DF7AEF2}" type="datetimeFigureOut">
              <a:rPr kumimoji="1" lang="zh-CN" altLang="en-US" smtClean="0"/>
              <a:t>2024/5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97392F-BA27-5F80-3CDA-E43F9D6A00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AC9092-7638-0323-FC1A-E0F5CB2FAE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66EE3-0461-8343-9A4D-030C629C31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503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2B5BB46-91B1-1458-D9B7-538A8F32B2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540" y="19751"/>
            <a:ext cx="5396459" cy="681849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883BF24-5C64-E8FD-77A8-A0927A110C0F}"/>
              </a:ext>
            </a:extLst>
          </p:cNvPr>
          <p:cNvSpPr txBox="1"/>
          <p:nvPr/>
        </p:nvSpPr>
        <p:spPr>
          <a:xfrm>
            <a:off x="6096001" y="3105834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" pitchFamily="2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zh-CN" altLang="zh-CN" sz="1800" b="1" dirty="0">
                <a:effectLst/>
                <a:latin typeface="Times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igure </a:t>
            </a:r>
            <a:r>
              <a:rPr lang="en-US" altLang="zh-CN" sz="1800" b="1" dirty="0">
                <a:effectLst/>
                <a:latin typeface="Times" pitchFamily="2" charset="0"/>
                <a:ea typeface="DengXia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zh-CN" altLang="zh-CN" sz="1800" b="1" dirty="0">
                <a:effectLst/>
                <a:latin typeface="Times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Distribution of HRD scores stratified by </a:t>
            </a:r>
            <a:r>
              <a:rPr lang="en-US" altLang="zh-CN" sz="1800" b="1" i="1" dirty="0">
                <a:effectLst/>
                <a:latin typeface="Times" pitchFamily="2" charset="0"/>
                <a:ea typeface="DengXian" panose="02010600030101010101" pitchFamily="2" charset="-122"/>
                <a:cs typeface="Times New Roman" panose="02020603050405020304" pitchFamily="18" charset="0"/>
              </a:rPr>
              <a:t>BRCA1/BRCA2</a:t>
            </a:r>
            <a:r>
              <a:rPr lang="zh-CN" altLang="zh-CN" sz="1800" b="1" i="1" dirty="0">
                <a:effectLst/>
                <a:latin typeface="Times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zh-CN" altLang="zh-CN" sz="1800" b="1" dirty="0">
                <a:effectLst/>
                <a:latin typeface="Times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tation status</a:t>
            </a:r>
            <a:endParaRPr lang="zh-CN" altLang="zh-CN" sz="1800" dirty="0">
              <a:effectLst/>
              <a:latin typeface="Times" pitchFamily="2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95107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79D06D2-015D-3776-7097-0E66C0CB47B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1026735" y="21368"/>
            <a:ext cx="4538949" cy="681526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C3CC75B-36A2-DAE8-E8B9-D5487CE6B473}"/>
              </a:ext>
            </a:extLst>
          </p:cNvPr>
          <p:cNvSpPr txBox="1"/>
          <p:nvPr/>
        </p:nvSpPr>
        <p:spPr>
          <a:xfrm>
            <a:off x="6096000" y="2690335"/>
            <a:ext cx="609600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2. Prognostic significance of HRD status, subgroup analysis</a:t>
            </a:r>
            <a:endParaRPr lang="zh-CN" altLang="zh-CN" sz="16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A) Distant metastasis-free survival among clinicopathological subgroups. (B) Overall survival among clinicopathological subgroups.</a:t>
            </a:r>
            <a:endParaRPr lang="zh-CN" altLang="zh-CN" sz="16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35234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79D06D2-015D-3776-7097-0E66C0CB47B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96849" y="23617"/>
            <a:ext cx="5841726" cy="681076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C3CC75B-36A2-DAE8-E8B9-D5487CE6B473}"/>
              </a:ext>
            </a:extLst>
          </p:cNvPr>
          <p:cNvSpPr txBox="1"/>
          <p:nvPr/>
        </p:nvSpPr>
        <p:spPr>
          <a:xfrm>
            <a:off x="5938575" y="1166841"/>
            <a:ext cx="6096000" cy="45243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zh-CN" altLang="zh-CN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3. Neoadjuvant chemotherapy efficacy and prognostic significance of HRD status stratified by pathology type</a:t>
            </a:r>
          </a:p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tribution of neoadjuvant chemotherapy efficacy stratified by HRD status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 patients with IDC(P = 0.073)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tribution of neoadjuvant chemotherapy efficacy stratified by HRD status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 patients with other pathology types (P = 0.271)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(C)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tant metastasis-free survival in patients with IDC. (D) Overall survival in patients with IDC.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(E)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tant metastasis-free survival in patients with other pathology types. (F) Overall survival in patients with other pathology types.</a:t>
            </a:r>
            <a:endParaRPr lang="zh-CN" altLang="zh-CN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s: HRD, homologous recombination deficiency; pCR, pathological complete response;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MFS, Distant metastasis-free survival; OS, Overall survival; IDC, invasive ductal carcinoma.</a:t>
            </a:r>
            <a:endParaRPr lang="zh-CN" altLang="zh-CN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zh-CN" altLang="zh-CN" sz="1800" dirty="0">
                <a:effectLst/>
                <a:latin typeface="DengXian" panose="02010600030101010101" pitchFamily="2" charset="-122"/>
                <a:ea typeface="Times New Roman" panose="02020603050405020304" pitchFamily="18" charset="0"/>
                <a:cs typeface="Times New Roman" panose="02020603050405020304" pitchFamily="18" charset="0"/>
              </a:rPr>
              <a:t>*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: P &lt; 0.05;</a:t>
            </a:r>
            <a:r>
              <a:rPr lang="zh-CN" altLang="zh-CN" sz="1800" dirty="0">
                <a:effectLst/>
                <a:latin typeface="DengXian" panose="02010600030101010101" pitchFamily="2" charset="-122"/>
                <a:ea typeface="Times New Roman" panose="02020603050405020304" pitchFamily="18" charset="0"/>
                <a:cs typeface="Times New Roman" panose="02020603050405020304" pitchFamily="18" charset="0"/>
              </a:rPr>
              <a:t> **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: P &lt; 0.01;</a:t>
            </a:r>
            <a:r>
              <a:rPr lang="zh-CN" altLang="zh-CN" sz="1800" dirty="0">
                <a:effectLst/>
                <a:latin typeface="DengXian" panose="02010600030101010101" pitchFamily="2" charset="-122"/>
                <a:ea typeface="Times New Roman" panose="02020603050405020304" pitchFamily="18" charset="0"/>
                <a:cs typeface="Times New Roman" panose="02020603050405020304" pitchFamily="18" charset="0"/>
              </a:rPr>
              <a:t> ***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: P &lt; 0.001; NS : not significant.</a:t>
            </a:r>
            <a:endParaRPr lang="zh-CN" altLang="zh-CN" sz="18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48588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79D06D2-015D-3776-7097-0E66C0CB47B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96849" y="23617"/>
            <a:ext cx="5841725" cy="681076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C3CC75B-36A2-DAE8-E8B9-D5487CE6B473}"/>
              </a:ext>
            </a:extLst>
          </p:cNvPr>
          <p:cNvSpPr txBox="1"/>
          <p:nvPr/>
        </p:nvSpPr>
        <p:spPr>
          <a:xfrm>
            <a:off x="5938574" y="889842"/>
            <a:ext cx="6096000" cy="50783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zh-CN" altLang="zh-CN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4</a:t>
            </a:r>
            <a:r>
              <a:rPr lang="zh-CN" altLang="zh-CN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Neoadjuvant chemotherapy efficacy and prognostic significance of HRD status stratified by chemotherapy backbone</a:t>
            </a:r>
          </a:p>
          <a:p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tribution of neoadjuvant chemotherapy efficacy stratified by HRD status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 patients treated with carboplatin and </a:t>
            </a:r>
            <a:r>
              <a:rPr lang="en-US" altLang="zh-CN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axane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P = 0.726)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B) 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tribution of neoadjuvant chemotherapy efficacy stratified by HRD status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 patients treated with carboplatin, </a:t>
            </a:r>
            <a:r>
              <a:rPr lang="en-US" altLang="zh-CN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axane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d anthracycline (P = 0.253)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(C)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tant metastasis-free survival in patients treated with carboplatin and </a:t>
            </a:r>
            <a:r>
              <a:rPr lang="en-US" altLang="zh-CN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axane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(D) Overall survival in patients treated with carboplatin and </a:t>
            </a:r>
            <a:r>
              <a:rPr lang="en-US" altLang="zh-CN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axane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(E)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istant metastasis-free survival in patients treated with carboplatin, </a:t>
            </a:r>
            <a:r>
              <a:rPr lang="en-US" altLang="zh-CN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axane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d anthracycline. (F) Overall survival in patients treated with carboplatin, </a:t>
            </a:r>
            <a:r>
              <a:rPr lang="en-US" altLang="zh-CN" dirty="0" err="1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axane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d anthracycline.</a:t>
            </a:r>
            <a:endParaRPr lang="zh-CN" altLang="zh-CN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s: HRD, homologous recombination deficiency; pCR, pathological complete response;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MFS, Distant metastasis-free survival; OS, Overall survival.</a:t>
            </a:r>
            <a:endParaRPr lang="zh-CN" altLang="zh-CN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*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: P &lt; 0.05;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**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: P &lt; 0.01;</a:t>
            </a:r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*** 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: P &lt; 0.001; NS : not significant.</a:t>
            </a:r>
            <a:endParaRPr lang="zh-CN" altLang="zh-CN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02251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79D06D2-015D-3776-7097-0E66C0CB47B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96849" y="23617"/>
            <a:ext cx="5841725" cy="681076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C3CC75B-36A2-DAE8-E8B9-D5487CE6B473}"/>
              </a:ext>
            </a:extLst>
          </p:cNvPr>
          <p:cNvSpPr txBox="1"/>
          <p:nvPr/>
        </p:nvSpPr>
        <p:spPr>
          <a:xfrm>
            <a:off x="5938574" y="2967334"/>
            <a:ext cx="6096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</a:t>
            </a:r>
            <a:r>
              <a:rPr lang="zh-CN" altLang="zh-CN" sz="1800" b="1" dirty="0">
                <a:effectLst/>
                <a:latin typeface="DengXian" panose="02010600030101010101" pitchFamily="2" charset="-122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zh-CN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zh-CN" altLang="zh-CN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Association between HRD and neoadjuvant chemotherapy </a:t>
            </a:r>
            <a:r>
              <a:rPr lang="en-US" altLang="zh-CN" b="1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linical response (P = 0.031)</a:t>
            </a:r>
            <a:endParaRPr lang="zh-CN" altLang="zh-CN" b="1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zh-CN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bbreviations: HRD, homologous recombination deficiency</a:t>
            </a:r>
            <a:r>
              <a:rPr lang="en-US" altLang="zh-CN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dirty="0"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5201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69</TotalTime>
  <Words>479</Words>
  <Application>Microsoft Macintosh PowerPoint</Application>
  <PresentationFormat>宽屏</PresentationFormat>
  <Paragraphs>23</Paragraphs>
  <Slides>5</Slides>
  <Notes>5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2" baseType="lpstr">
      <vt:lpstr>DengXian</vt:lpstr>
      <vt:lpstr>DengXian</vt:lpstr>
      <vt:lpstr>等线 Light</vt:lpstr>
      <vt:lpstr>Arial</vt:lpstr>
      <vt:lpstr>Times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jie Lu</dc:creator>
  <cp:lastModifiedBy>Yujie Lu</cp:lastModifiedBy>
  <cp:revision>5</cp:revision>
  <dcterms:created xsi:type="dcterms:W3CDTF">2024-02-05T09:22:30Z</dcterms:created>
  <dcterms:modified xsi:type="dcterms:W3CDTF">2024-06-12T04:48:09Z</dcterms:modified>
</cp:coreProperties>
</file>